
<file path=[Content_Types].xml><?xml version="1.0" encoding="utf-8"?>
<Types xmlns="http://schemas.openxmlformats.org/package/2006/content-types">
  <Default Extension="vml" ContentType="application/vnd.openxmlformats-officedocument.vmlDrawing"/>
  <Default Extension="bin" ContentType="application/vnd.openxmlformats-officedocument.oleObject"/>
  <Default Extension="emf" ContentType="image/x-emf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61" r:id="rId3"/>
    <p:sldId id="262" r:id="rId4"/>
    <p:sldId id="263" r:id="rId5"/>
    <p:sldId id="264" r:id="rId6"/>
  </p:sldIdLst>
  <p:sldSz cx="12192000" cy="6858000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100" d="100"/>
          <a:sy n="100" d="100"/>
        </p:scale>
        <p:origin x="72" y="106"/>
      </p:cViewPr>
      <p:guideLst>
        <p:guide orient="horz" pos="2160"/>
        <p:guide pos="3865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notesMaster" Target="notesMasters/notes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69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mlDrawing" Target="../drawings/vmlDrawing1.vml"/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2.emf"/><Relationship Id="rId3" Type="http://schemas.openxmlformats.org/officeDocument/2006/relationships/oleObject" Target="../embeddings/oleObject2.bin"/><Relationship Id="rId2" Type="http://schemas.openxmlformats.org/officeDocument/2006/relationships/image" Target="../media/image1.emf"/><Relationship Id="rId1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vmlDrawing" Target="../drawings/vmlDrawing2.vml"/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Relationship Id="rId3" Type="http://schemas.openxmlformats.org/officeDocument/2006/relationships/oleObject" Target="../embeddings/oleObject5.bin"/><Relationship Id="rId2" Type="http://schemas.openxmlformats.org/officeDocument/2006/relationships/image" Target="../media/image4.emf"/><Relationship Id="rId1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65.xml"/><Relationship Id="rId8" Type="http://schemas.openxmlformats.org/officeDocument/2006/relationships/image" Target="../media/image9.emf"/><Relationship Id="rId7" Type="http://schemas.openxmlformats.org/officeDocument/2006/relationships/oleObject" Target="../embeddings/oleObject9.bin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4" Type="http://schemas.openxmlformats.org/officeDocument/2006/relationships/tags" Target="../tags/tag64.xml"/><Relationship Id="rId3" Type="http://schemas.openxmlformats.org/officeDocument/2006/relationships/image" Target="../media/image7.emf"/><Relationship Id="rId2" Type="http://schemas.openxmlformats.org/officeDocument/2006/relationships/oleObject" Target="../embeddings/oleObject7.bin"/><Relationship Id="rId12" Type="http://schemas.openxmlformats.org/officeDocument/2006/relationships/vmlDrawing" Target="../drawings/vmlDrawing3.vml"/><Relationship Id="rId11" Type="http://schemas.openxmlformats.org/officeDocument/2006/relationships/slideLayout" Target="../slideLayouts/slideLayout7.xml"/><Relationship Id="rId10" Type="http://schemas.openxmlformats.org/officeDocument/2006/relationships/tags" Target="../tags/tag66.xml"/><Relationship Id="rId1" Type="http://schemas.openxmlformats.org/officeDocument/2006/relationships/tags" Target="../tags/tag63.xml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1.xml"/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10.tiff"/><Relationship Id="rId2" Type="http://schemas.openxmlformats.org/officeDocument/2006/relationships/tags" Target="../tags/tag68.xml"/><Relationship Id="rId1" Type="http://schemas.openxmlformats.org/officeDocument/2006/relationships/tags" Target="../tags/tag6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40"/>
          <p:cNvSpPr txBox="1"/>
          <p:nvPr/>
        </p:nvSpPr>
        <p:spPr>
          <a:xfrm>
            <a:off x="607695" y="5411470"/>
            <a:ext cx="11235055" cy="1322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60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The incidence of SAP according to different nutritional risk groups of three malnutrition indexes (A) PNI, (B) CONUT, and (C) GNRI.Abbreviation: CONUT, controlling nutritional status score; GNRI, geriatric nutritional risk index; PNI, prognostic nutritional index; SAP, stroke-associated pneumonia.</a:t>
            </a:r>
            <a:endParaRPr lang="en-US" sz="1600">
              <a:solidFill>
                <a:schemeClr val="tx1"/>
              </a:solidFill>
              <a:latin typeface="Times New Roman" panose="02020603050405020304" pitchFamily="18" charset="0"/>
              <a:ea typeface="宋体" panose="02010600030101010101" pitchFamily="2" charset="-122"/>
              <a:sym typeface="+mn-ea"/>
            </a:endParaRPr>
          </a:p>
          <a:p>
            <a:pPr algn="l"/>
            <a:endParaRPr lang="en-US" altLang="en-US" sz="1600" dirty="0">
              <a:solidFill>
                <a:schemeClr val="tx1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graphicFrame>
        <p:nvGraphicFramePr>
          <p:cNvPr id="2" name="对象 1"/>
          <p:cNvGraphicFramePr/>
          <p:nvPr/>
        </p:nvGraphicFramePr>
        <p:xfrm>
          <a:off x="261620" y="1271588"/>
          <a:ext cx="4101465" cy="33102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" r:id="rId1" imgW="3436620" imgH="2979420" progId="Prism8.Document">
                  <p:embed/>
                </p:oleObj>
              </mc:Choice>
              <mc:Fallback>
                <p:oleObj name="" r:id="rId1" imgW="3436620" imgH="2979420" progId="Prism8.Document">
                  <p:embed/>
                  <p:pic>
                    <p:nvPicPr>
                      <p:cNvPr id="0" name="图片 3"/>
                      <p:cNvPicPr/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261620" y="1271588"/>
                        <a:ext cx="4101465" cy="33102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本框 12"/>
          <p:cNvSpPr txBox="1"/>
          <p:nvPr/>
        </p:nvSpPr>
        <p:spPr>
          <a:xfrm>
            <a:off x="1042035" y="4244340"/>
            <a:ext cx="254000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PNI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036955" y="3960495"/>
            <a:ext cx="10236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007235" y="3960495"/>
            <a:ext cx="7391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664460" y="3960495"/>
            <a:ext cx="12128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od&amp;Sev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5400000">
            <a:off x="-242570" y="2658110"/>
            <a:ext cx="15379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SAP 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7" name="对象 16"/>
          <p:cNvGraphicFramePr/>
          <p:nvPr/>
        </p:nvGraphicFramePr>
        <p:xfrm>
          <a:off x="3966211" y="1271588"/>
          <a:ext cx="4101465" cy="33102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" r:id="rId3" imgW="3436620" imgH="2979420" progId="Prism8.Document">
                  <p:embed/>
                </p:oleObj>
              </mc:Choice>
              <mc:Fallback>
                <p:oleObj name="" r:id="rId3" imgW="3436620" imgH="2979420" progId="Prism8.Document">
                  <p:embed/>
                  <p:pic>
                    <p:nvPicPr>
                      <p:cNvPr id="0" name="图片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66211" y="1271588"/>
                        <a:ext cx="4101465" cy="33102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文本框 18"/>
          <p:cNvSpPr txBox="1"/>
          <p:nvPr/>
        </p:nvSpPr>
        <p:spPr>
          <a:xfrm>
            <a:off x="4857274" y="4244340"/>
            <a:ext cx="254000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UT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5400000">
            <a:off x="3402330" y="2658110"/>
            <a:ext cx="15379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SAP 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5" name="对象 24"/>
          <p:cNvGraphicFramePr/>
          <p:nvPr/>
        </p:nvGraphicFramePr>
        <p:xfrm>
          <a:off x="7813993" y="1271588"/>
          <a:ext cx="4028440" cy="33102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" r:id="rId5" imgW="3375660" imgH="2979420" progId="Prism8.Document">
                  <p:embed/>
                </p:oleObj>
              </mc:Choice>
              <mc:Fallback>
                <p:oleObj name="" r:id="rId5" imgW="3375660" imgH="2979420" progId="Prism8.Document">
                  <p:embed/>
                  <p:pic>
                    <p:nvPicPr>
                      <p:cNvPr id="0" name="图片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813993" y="1271588"/>
                        <a:ext cx="4028440" cy="33102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文本框 26"/>
          <p:cNvSpPr txBox="1"/>
          <p:nvPr/>
        </p:nvSpPr>
        <p:spPr>
          <a:xfrm>
            <a:off x="8718233" y="4220210"/>
            <a:ext cx="254000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RI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 rot="5400000">
            <a:off x="7213600" y="2658110"/>
            <a:ext cx="15379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SAP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221740" y="1758950"/>
            <a:ext cx="121475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4904105" y="1758950"/>
            <a:ext cx="121475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8770620" y="1769110"/>
            <a:ext cx="121475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4765040" y="3960495"/>
            <a:ext cx="10236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5765800" y="3960495"/>
            <a:ext cx="7391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6412865" y="3960495"/>
            <a:ext cx="12128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od&amp;Sev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8584565" y="3960495"/>
            <a:ext cx="10236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9575165" y="3960495"/>
            <a:ext cx="7391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0232390" y="3960495"/>
            <a:ext cx="12128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od&amp;Sev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40"/>
          <p:cNvSpPr txBox="1"/>
          <p:nvPr/>
        </p:nvSpPr>
        <p:spPr>
          <a:xfrm>
            <a:off x="579755" y="5725795"/>
            <a:ext cx="1134808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The incidence of all-cause mortality according to different nutritional risk groups of three malnutrition indexes (A) PNI, (B) CONUT, and (C) GNRI.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: CONUT, controlling nutritional status score; GNRI, geriatric nutritional risk index; PNI, prognostic nutritional index.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对象 1"/>
          <p:cNvGraphicFramePr/>
          <p:nvPr/>
        </p:nvGraphicFramePr>
        <p:xfrm>
          <a:off x="261620" y="1271588"/>
          <a:ext cx="4101465" cy="33102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" r:id="rId1" imgW="3436620" imgH="2979420" progId="Prism8.Document">
                  <p:embed/>
                </p:oleObj>
              </mc:Choice>
              <mc:Fallback>
                <p:oleObj name="" r:id="rId1" imgW="3436620" imgH="2979420" progId="Prism8.Document">
                  <p:embed/>
                  <p:pic>
                    <p:nvPicPr>
                      <p:cNvPr id="0" name="图片 3"/>
                      <p:cNvPicPr/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261620" y="1271588"/>
                        <a:ext cx="4101465" cy="33102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本框 12"/>
          <p:cNvSpPr txBox="1"/>
          <p:nvPr/>
        </p:nvSpPr>
        <p:spPr>
          <a:xfrm>
            <a:off x="1042035" y="4244340"/>
            <a:ext cx="254000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PNI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036955" y="3960495"/>
            <a:ext cx="10236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007235" y="3960495"/>
            <a:ext cx="7391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664460" y="3960495"/>
            <a:ext cx="12128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od&amp;Sev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5400000">
            <a:off x="-242570" y="2658110"/>
            <a:ext cx="15379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eath 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7" name="对象 16"/>
          <p:cNvGraphicFramePr/>
          <p:nvPr/>
        </p:nvGraphicFramePr>
        <p:xfrm>
          <a:off x="3966211" y="1271588"/>
          <a:ext cx="4101465" cy="33102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" r:id="rId3" imgW="3436620" imgH="2979420" progId="Prism8.Document">
                  <p:embed/>
                </p:oleObj>
              </mc:Choice>
              <mc:Fallback>
                <p:oleObj name="" r:id="rId3" imgW="3436620" imgH="2979420" progId="Prism8.Document">
                  <p:embed/>
                  <p:pic>
                    <p:nvPicPr>
                      <p:cNvPr id="0" name="图片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66211" y="1271588"/>
                        <a:ext cx="4101465" cy="33102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文本框 18"/>
          <p:cNvSpPr txBox="1"/>
          <p:nvPr/>
        </p:nvSpPr>
        <p:spPr>
          <a:xfrm>
            <a:off x="4857274" y="4244340"/>
            <a:ext cx="254000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UT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5400000">
            <a:off x="3402330" y="2658110"/>
            <a:ext cx="15379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Death</a:t>
            </a: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5" name="对象 24"/>
          <p:cNvGraphicFramePr/>
          <p:nvPr/>
        </p:nvGraphicFramePr>
        <p:xfrm>
          <a:off x="7777481" y="1271588"/>
          <a:ext cx="4101465" cy="33102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" r:id="rId5" imgW="3436620" imgH="2979420" progId="Prism8.Document">
                  <p:embed/>
                </p:oleObj>
              </mc:Choice>
              <mc:Fallback>
                <p:oleObj name="" r:id="rId5" imgW="3436620" imgH="2979420" progId="Prism8.Document">
                  <p:embed/>
                  <p:pic>
                    <p:nvPicPr>
                      <p:cNvPr id="0" name="图片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777481" y="1271588"/>
                        <a:ext cx="4101465" cy="33102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文本框 26"/>
          <p:cNvSpPr txBox="1"/>
          <p:nvPr/>
        </p:nvSpPr>
        <p:spPr>
          <a:xfrm>
            <a:off x="8718233" y="4220210"/>
            <a:ext cx="254000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RI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 rot="5400000">
            <a:off x="7213600" y="2658110"/>
            <a:ext cx="15379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Death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221740" y="1758950"/>
            <a:ext cx="121475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4904105" y="1758950"/>
            <a:ext cx="121475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 =0.003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8770620" y="1769110"/>
            <a:ext cx="121475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4765040" y="3960495"/>
            <a:ext cx="10236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5765800" y="3960495"/>
            <a:ext cx="7391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6412865" y="3960495"/>
            <a:ext cx="12128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od&amp;Sev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8584565" y="3960495"/>
            <a:ext cx="10236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9575165" y="3960495"/>
            <a:ext cx="7391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0232390" y="3960495"/>
            <a:ext cx="12128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od&amp;Sev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对象 17"/>
          <p:cNvGraphicFramePr/>
          <p:nvPr>
            <p:custDataLst>
              <p:tags r:id="rId1"/>
            </p:custDataLst>
          </p:nvPr>
        </p:nvGraphicFramePr>
        <p:xfrm>
          <a:off x="8068945" y="1623695"/>
          <a:ext cx="3706495" cy="27266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" name="" r:id="rId2" imgW="3147060" imgH="2453640" progId="Prism8.Document">
                  <p:embed/>
                </p:oleObj>
              </mc:Choice>
              <mc:Fallback>
                <p:oleObj name="" r:id="rId2" imgW="3147060" imgH="2453640" progId="Prism8.Document">
                  <p:embed/>
                  <p:pic>
                    <p:nvPicPr>
                      <p:cNvPr id="0" name="图片 3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068945" y="1623695"/>
                        <a:ext cx="3706495" cy="27266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/>
          <p:cNvGraphicFramePr/>
          <p:nvPr>
            <p:custDataLst>
              <p:tags r:id="rId4"/>
            </p:custDataLst>
          </p:nvPr>
        </p:nvGraphicFramePr>
        <p:xfrm>
          <a:off x="4276725" y="1557020"/>
          <a:ext cx="3706495" cy="27266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" name="" r:id="rId5" imgW="3147060" imgH="2453640" progId="Prism8.Document">
                  <p:embed/>
                </p:oleObj>
              </mc:Choice>
              <mc:Fallback>
                <p:oleObj name="" r:id="rId5" imgW="3147060" imgH="2453640" progId="Prism8.Document">
                  <p:embed/>
                  <p:pic>
                    <p:nvPicPr>
                      <p:cNvPr id="0" name="图片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76725" y="1557020"/>
                        <a:ext cx="3706495" cy="27266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文本框 40"/>
          <p:cNvSpPr txBox="1"/>
          <p:nvPr/>
        </p:nvSpPr>
        <p:spPr>
          <a:xfrm>
            <a:off x="358140" y="5665470"/>
            <a:ext cx="11635740" cy="1076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</a:t>
            </a:r>
            <a:r>
              <a:rPr lang="en-US" sz="160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The length of stay according to different nutritional risk groups of three malnutrition indexes (A) PNI, (B) CONUT, and (C) GNRI.Abbreviation: CONUT, controlling nutritional status score; GNRI, geriatric nutritional risk index; PNI, prognostic nutritional index.</a:t>
            </a:r>
            <a:endParaRPr lang="en-US" sz="1600">
              <a:solidFill>
                <a:schemeClr val="tx1"/>
              </a:solidFill>
              <a:latin typeface="Times New Roman" panose="02020603050405020304" pitchFamily="18" charset="0"/>
              <a:ea typeface="宋体" panose="02010600030101010101" pitchFamily="2" charset="-122"/>
              <a:sym typeface="+mn-ea"/>
            </a:endParaRPr>
          </a:p>
          <a:p>
            <a:pPr algn="l"/>
            <a:endParaRPr lang="en-US" altLang="en-US" sz="1600" dirty="0">
              <a:solidFill>
                <a:schemeClr val="tx1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graphicFrame>
        <p:nvGraphicFramePr>
          <p:cNvPr id="2" name="对象 1"/>
          <p:cNvGraphicFramePr/>
          <p:nvPr/>
        </p:nvGraphicFramePr>
        <p:xfrm>
          <a:off x="434340" y="1563370"/>
          <a:ext cx="3706495" cy="27266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" r:id="rId7" imgW="3147060" imgH="2453640" progId="Prism8.Document">
                  <p:embed/>
                </p:oleObj>
              </mc:Choice>
              <mc:Fallback>
                <p:oleObj name="" r:id="rId7" imgW="3147060" imgH="2453640" progId="Prism8.Document">
                  <p:embed/>
                  <p:pic>
                    <p:nvPicPr>
                      <p:cNvPr id="0" name="图片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34340" y="1563370"/>
                        <a:ext cx="3706495" cy="27266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本框 12"/>
          <p:cNvSpPr txBox="1"/>
          <p:nvPr/>
        </p:nvSpPr>
        <p:spPr>
          <a:xfrm>
            <a:off x="1042035" y="4244340"/>
            <a:ext cx="254000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PNI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036955" y="3960495"/>
            <a:ext cx="10236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007235" y="3960495"/>
            <a:ext cx="7391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664460" y="3960495"/>
            <a:ext cx="12128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od&amp;Sev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5400000">
            <a:off x="-493395" y="2771775"/>
            <a:ext cx="20396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Length of stay 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day)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857274" y="4244340"/>
            <a:ext cx="254000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UT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8718233" y="4220210"/>
            <a:ext cx="254000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RI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221740" y="1758950"/>
            <a:ext cx="121475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0.006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4904105" y="1758950"/>
            <a:ext cx="121475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 =0.021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8770620" y="1769110"/>
            <a:ext cx="121475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 = 0.099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4765040" y="3960495"/>
            <a:ext cx="10236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5765800" y="3960495"/>
            <a:ext cx="7391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6412865" y="3960495"/>
            <a:ext cx="12128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od&amp;Sev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8584565" y="3960495"/>
            <a:ext cx="10236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9575165" y="3960495"/>
            <a:ext cx="7391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0232390" y="3960495"/>
            <a:ext cx="12128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Mod&amp;Sev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>
            <p:custDataLst>
              <p:tags r:id="rId9"/>
            </p:custDataLst>
          </p:nvPr>
        </p:nvSpPr>
        <p:spPr>
          <a:xfrm rot="5400000">
            <a:off x="3301365" y="2746375"/>
            <a:ext cx="20396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Length of stay 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day)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>
            <p:custDataLst>
              <p:tags r:id="rId10"/>
            </p:custDataLst>
          </p:nvPr>
        </p:nvSpPr>
        <p:spPr>
          <a:xfrm rot="5400000">
            <a:off x="7055485" y="2803525"/>
            <a:ext cx="20396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Length of stay 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day)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8" name="表格 7"/>
          <p:cNvGraphicFramePr/>
          <p:nvPr>
            <p:custDataLst>
              <p:tags r:id="rId1"/>
            </p:custDataLst>
          </p:nvPr>
        </p:nvGraphicFramePr>
        <p:xfrm>
          <a:off x="2019935" y="843280"/>
          <a:ext cx="941070" cy="541147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41070"/>
              </a:tblGrid>
              <a:tr h="356870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NI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58140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UT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86080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NRI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57505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000" b="1" baseline="300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S</a:t>
                      </a:r>
                      <a:r>
                        <a:rPr lang="en-US" sz="1000" b="1" baseline="300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en-US" sz="1000" b="1" baseline="300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56870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HSS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58140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I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57505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57505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68935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ophil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68300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mphocyte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56870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LR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57505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I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56870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C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57505">
                <a:tc>
                  <a:txBody>
                    <a:bodyPr/>
                    <a:p>
                      <a:pPr algn="r">
                        <a:buClrTx/>
                        <a:buSzTx/>
                        <a:buFontTx/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telet</a:t>
                      </a:r>
                      <a:endParaRPr 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  <a:tr h="356870">
                <a:tc>
                  <a:txBody>
                    <a:bodyPr/>
                    <a:p>
                      <a:pPr algn="r">
                        <a:buClrTx/>
                        <a:buSzTx/>
                        <a:buFontTx/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nocytes</a:t>
                      </a:r>
                      <a:endParaRPr lang="en-US" sz="1000" b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vert="horz" anchor="ctr" anchorCtr="0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2" name="表格 21"/>
          <p:cNvGraphicFramePr/>
          <p:nvPr/>
        </p:nvGraphicFramePr>
        <p:xfrm>
          <a:off x="3018155" y="-28575"/>
          <a:ext cx="5829300" cy="87249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8620"/>
                <a:gridCol w="388620"/>
                <a:gridCol w="388620"/>
                <a:gridCol w="388620"/>
                <a:gridCol w="388620"/>
                <a:gridCol w="388620"/>
                <a:gridCol w="388620"/>
                <a:gridCol w="388620"/>
                <a:gridCol w="388620"/>
                <a:gridCol w="388620"/>
                <a:gridCol w="388620"/>
                <a:gridCol w="388620"/>
                <a:gridCol w="388620"/>
                <a:gridCol w="388620"/>
                <a:gridCol w="388620"/>
              </a:tblGrid>
              <a:tr h="87249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NI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ONUT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NRI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</a:t>
                      </a:r>
                      <a:r>
                        <a:rPr lang="en-US" sz="1000" b="1" baseline="3000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2</a:t>
                      </a: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DS</a:t>
                      </a:r>
                      <a:r>
                        <a:rPr lang="en-US" sz="1000" b="1" baseline="3000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2</a:t>
                      </a:r>
                      <a:endParaRPr lang="en-US" altLang="en-US" sz="1000" b="1" baseline="3000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IHSS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SI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ender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ge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eutrophil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Lymphocyte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LR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II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WBC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latelet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Monocytes</a:t>
                      </a:r>
                      <a:endParaRPr lang="en-US" altLang="en-US" sz="10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vert="vert270" anchor="ctr" anchorCtr="0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6" name="表格 25"/>
          <p:cNvGraphicFramePr/>
          <p:nvPr>
            <p:custDataLst>
              <p:tags r:id="rId2"/>
            </p:custDataLst>
          </p:nvPr>
        </p:nvGraphicFramePr>
        <p:xfrm>
          <a:off x="9164320" y="739140"/>
          <a:ext cx="1014730" cy="58185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14730"/>
              </a:tblGrid>
              <a:tr h="528955"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  <a:tr h="528955"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US" altLang="zh-CN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  <a:tr h="528955"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en-US" altLang="zh-CN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  <a:tr h="528955"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altLang="zh-CN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  <a:tr h="528955"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altLang="zh-CN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  <a:tr h="528955"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zh-CN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  <a:tr h="528955"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</a:t>
                      </a:r>
                      <a:endParaRPr lang="en-US" altLang="zh-CN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  <a:tr h="528955"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</a:t>
                      </a:r>
                      <a:endParaRPr lang="en-US" altLang="zh-CN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  <a:tr h="528955"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6</a:t>
                      </a:r>
                      <a:endParaRPr lang="en-US" altLang="zh-CN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  <a:tr h="528955"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8</a:t>
                      </a:r>
                      <a:endParaRPr lang="en-US" altLang="zh-CN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  <a:tr h="528955"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n-US" altLang="zh-CN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27" name="文本框 26"/>
          <p:cNvSpPr txBox="1"/>
          <p:nvPr/>
        </p:nvSpPr>
        <p:spPr>
          <a:xfrm>
            <a:off x="287020" y="6169660"/>
            <a:ext cx="11675110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Supplementary Figure 4.</a:t>
            </a: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</a:t>
            </a: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Spe</a:t>
            </a: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rman correlation anaysis analyse the correlation of three malnutrition scoring systems and age, systemic inflammatory markers, the severity of IS, and the severity index of pneumonia.Abbreviation: SII, systemic inflammatory index; WBC, white blood cell count; NLR, neutrophil to lymphocyte ratio; PSI, pneumonia severity index.</a:t>
            </a:r>
            <a:endParaRPr lang="en-US" altLang="en-US" sz="1200">
              <a:solidFill>
                <a:schemeClr val="tx1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pPr algn="r"/>
            <a:endParaRPr lang="en-US" altLang="en-US" sz="1200">
              <a:solidFill>
                <a:schemeClr val="tx1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" name="图片 1" descr="相关性热图_00"/>
          <p:cNvPicPr>
            <a:picLocks noChangeAspect="1"/>
          </p:cNvPicPr>
          <p:nvPr/>
        </p:nvPicPr>
        <p:blipFill>
          <a:blip r:embed="rId3"/>
          <a:srcRect l="18391" t="18807" r="21845" b="2015"/>
          <a:stretch>
            <a:fillRect/>
          </a:stretch>
        </p:blipFill>
        <p:spPr>
          <a:xfrm>
            <a:off x="2961005" y="843280"/>
            <a:ext cx="6247765" cy="534543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TABLE_ENDDRAG_ORIGIN_RECT" val="79*457"/>
  <p:tag name="TABLE_ENDDRAG_RECT" val="721*58*79*458"/>
</p:tagLst>
</file>

<file path=ppt/tags/tag68.xml><?xml version="1.0" encoding="utf-8"?>
<p:tagLst xmlns:p="http://schemas.openxmlformats.org/presentationml/2006/main">
  <p:tag name="TABLE_ENDDRAG_ORIGIN_RECT" val="425*78"/>
  <p:tag name="TABLE_ENDDRAG_RECT" val="265*0*425*78"/>
</p:tagLst>
</file>

<file path=ppt/tags/tag69.xml><?xml version="1.0" encoding="utf-8"?>
<p:tagLst xmlns:p="http://schemas.openxmlformats.org/presentationml/2006/main">
  <p:tag name="COMMONDATA" val="eyJoZGlkIjoiNDc2MDdkZTVjZTJmZjZlZWM4YmUzNmExZjFjZWI2NTgifQ=="/>
  <p:tag name="KSO_WPP_MARK_KEY" val="d8b6008d-8869-4b9e-8a5d-6018996dcb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33</Words>
  <Application>WPS 演示</Application>
  <PresentationFormat>宽屏</PresentationFormat>
  <Paragraphs>205</Paragraphs>
  <Slides>4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9</vt:i4>
      </vt:variant>
      <vt:variant>
        <vt:lpstr>幻灯片标题</vt:lpstr>
      </vt:variant>
      <vt:variant>
        <vt:i4>4</vt:i4>
      </vt:variant>
    </vt:vector>
  </HeadingPairs>
  <TitlesOfParts>
    <vt:vector size="23" baseType="lpstr">
      <vt:lpstr>Arial</vt:lpstr>
      <vt:lpstr>宋体</vt:lpstr>
      <vt:lpstr>Wingdings</vt:lpstr>
      <vt:lpstr>微软雅黑</vt:lpstr>
      <vt:lpstr>Wingdings</vt:lpstr>
      <vt:lpstr>Times New Roman</vt:lpstr>
      <vt:lpstr>Times New Roman</vt:lpstr>
      <vt:lpstr>Arial Unicode MS</vt:lpstr>
      <vt:lpstr>Calibri</vt:lpstr>
      <vt:lpstr>Office 主题​​</vt:lpstr>
      <vt:lpstr>Prism8.Document</vt:lpstr>
      <vt:lpstr>Prism8.Document</vt:lpstr>
      <vt:lpstr>Prism8.Document</vt:lpstr>
      <vt:lpstr>Prism8.Document</vt:lpstr>
      <vt:lpstr>Prism8.Document</vt:lpstr>
      <vt:lpstr>Prism8.Document</vt:lpstr>
      <vt:lpstr>Prism8.Document</vt:lpstr>
      <vt:lpstr>Prism8.Document</vt:lpstr>
      <vt:lpstr>Prism8.Document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jy</cp:lastModifiedBy>
  <cp:revision>185</cp:revision>
  <dcterms:created xsi:type="dcterms:W3CDTF">2019-06-19T02:08:00Z</dcterms:created>
  <dcterms:modified xsi:type="dcterms:W3CDTF">2023-07-01T02:04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4309</vt:lpwstr>
  </property>
  <property fmtid="{D5CDD505-2E9C-101B-9397-08002B2CF9AE}" pid="3" name="ICV">
    <vt:lpwstr>2B758FC1FC6E48279397599B06F8E0A1_13</vt:lpwstr>
  </property>
</Properties>
</file>